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57" r:id="rId3"/>
    <p:sldId id="285" r:id="rId4"/>
    <p:sldId id="276" r:id="rId5"/>
    <p:sldId id="260" r:id="rId6"/>
    <p:sldId id="261" r:id="rId7"/>
    <p:sldId id="262" r:id="rId8"/>
    <p:sldId id="263" r:id="rId9"/>
    <p:sldId id="284" r:id="rId10"/>
    <p:sldId id="283" r:id="rId11"/>
    <p:sldId id="281" r:id="rId12"/>
    <p:sldId id="264" r:id="rId13"/>
    <p:sldId id="265" r:id="rId14"/>
    <p:sldId id="266" r:id="rId15"/>
    <p:sldId id="267" r:id="rId16"/>
    <p:sldId id="269" r:id="rId17"/>
    <p:sldId id="277" r:id="rId18"/>
    <p:sldId id="270" r:id="rId19"/>
    <p:sldId id="271" r:id="rId20"/>
    <p:sldId id="272" r:id="rId21"/>
    <p:sldId id="275" r:id="rId22"/>
    <p:sldId id="286" r:id="rId23"/>
    <p:sldId id="282" r:id="rId24"/>
    <p:sldId id="273" r:id="rId25"/>
    <p:sldId id="274" r:id="rId2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97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56F872-430B-1008-AD17-A4BC97DBF7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E55CB05-8DBE-18AD-955A-0B3F63F072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6BFBC5-B996-7126-24AE-429DEA96C7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4C992C-945D-A816-F483-0CE0943AF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B673A6-F65B-9B27-3C25-6044A7D2B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994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B839-0224-F018-AEC6-0CF1FF00CB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52659D-C284-5B48-7239-F0F4793595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68E6A3-569A-705D-9349-C61C5474FB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6EE2D7-0F01-749C-1F04-3DB5ECAB3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39764D-952B-5676-6777-84F91C44B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749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BB1D5C-6E9D-92BA-06B8-B1623755C7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AE9B15-C608-D758-0C8E-1003175DDF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CC4E0D-593D-51D5-1416-1640F235FC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244670-3B48-6665-50B2-CF72B5918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BE4586-5F1D-A899-5D19-E9F03B025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320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9B33CA-2201-9CF7-89F6-2DB9FC3AB2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6DD6F2-EC7D-CAFF-1277-2F5CE3650E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D43205-DB9C-2BF2-2788-A3004BE79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0E417E-DEE6-665A-3E5B-DBEA61568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A7EFBE-9BA6-88E1-5CED-82970A089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85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62FFEE-5D1F-AC85-BE02-6E3472DCE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6AD483-A53F-6F86-244E-66BDD6A4BA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0E031A-C50B-D640-8B26-35A4AF307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489225-6E6F-061E-C744-B2DDA5D74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0FF46D-8E75-C56B-4E9F-F167933DA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663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AFFD4-6888-B37F-BCA4-2379A3B128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A448EC-3052-9697-B5BD-A1085D32A0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C6F9B6-0EAE-0A32-06B9-E5DD32BC32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B8EAD2-1D10-3934-0011-27B1A16B8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67BA00-63F1-39C3-DCE3-679E66971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73554F-430C-8FE9-B775-683902013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836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3A6B9-07E0-5E5A-A644-A2619960C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34A0B1-524F-BB18-1032-FA34F27A5A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4AB9DA-ED0E-6DED-DE3D-8D8063C827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22F0CF4-E15F-242B-D28B-BF26A90D71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8DE793-4E70-B3A6-5F0E-B0359CF22E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42A77C-82F6-2E3E-4428-40B135978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F63A81-27A9-892B-4489-1E33E70213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76038B-1A2C-67C5-8CB8-4004B4099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978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E8AEF2-1EDF-26C3-828F-EFA195CFA1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82EBE3-5472-CA92-75FD-F9E4A48D9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B2EA603-F92C-A367-06F9-9B1C5C95C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68C8E2-3D3B-81F3-4CBA-7708B3C07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462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BCA4FB-54D7-DD07-D914-889E82B28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742F87-064A-9385-B558-CDA2EFF35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0603D9-D6A0-ED4E-508E-9B540ECC3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333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D69B00-EE48-B7EF-01F7-5E1EE40627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FF383C-42EB-47B6-E0C0-EAD6ED6C19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27F1A3-F622-2586-2459-ABB9AEAA0F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E4ABC2-A7E9-6426-B1C4-479A0C9B2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686052-2B31-097A-96C4-1382E2C87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60C0F7-07B4-B3CA-370D-6A65895DD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4631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2B0B2A-8EE3-F43A-9DD8-3907DE7CCE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105EFA-C063-2D2F-0447-AD8D8F238E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2ABB11-5DB7-F114-D23D-4A3E054C0C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D2235C-4BD2-79E7-1F08-5607D0963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39541D-1C5C-F2D9-82DD-6D41BE7CD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4E4A11-9DD2-A74D-4331-2B45D65AD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154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F1A2E0-9FB0-A4DC-CC07-848D41BA24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9120F4-E695-B3C5-D148-A84E46E245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3B4FAA-D24D-CFE1-21AA-5EEA20B215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76C5AB6-96A8-4D45-B54B-B40818C875B1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46F173-0F41-13AA-EFA8-E74472C28C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7FFCF7-1A08-58BA-3D22-AEF89A8027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272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ABC69BCF-007A-1C20-A44E-1C13ADE46A0A}"/>
              </a:ext>
            </a:extLst>
          </p:cNvPr>
          <p:cNvSpPr txBox="1">
            <a:spLocks/>
          </p:cNvSpPr>
          <p:nvPr/>
        </p:nvSpPr>
        <p:spPr>
          <a:xfrm>
            <a:off x="868680" y="0"/>
            <a:ext cx="10454640" cy="826656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10000"/>
              </a:lnSpc>
              <a:spcAft>
                <a:spcPts val="600"/>
              </a:spcAft>
            </a:pP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</a:p>
          <a:p>
            <a:pPr algn="ctr">
              <a:lnSpc>
                <a:spcPct val="110000"/>
              </a:lnSpc>
              <a:spcAft>
                <a:spcPts val="600"/>
              </a:spcAft>
            </a:pP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ugs docking human IL-17AF/IL-17RA (5nan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CF2A19E-A090-6B61-0D1F-E8D64A4DDDAD}"/>
              </a:ext>
            </a:extLst>
          </p:cNvPr>
          <p:cNvSpPr txBox="1"/>
          <p:nvPr/>
        </p:nvSpPr>
        <p:spPr>
          <a:xfrm>
            <a:off x="1749704" y="1306206"/>
            <a:ext cx="849157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>
                <a:latin typeface="Times New Roman" panose="02020603050405020304" pitchFamily="18" charset="0"/>
                <a:cs typeface="Times New Roman" panose="02020603050405020304" pitchFamily="18" charset="0"/>
              </a:rPr>
              <a:t>Table S4 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ing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mmary of drug docking human IL-17/IL-17AF/IL-17RA (5nan) via binding to critical residues for binding and glycosylation.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5265B78-223F-DFC6-8360-8351426A58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448426"/>
              </p:ext>
            </p:extLst>
          </p:nvPr>
        </p:nvGraphicFramePr>
        <p:xfrm>
          <a:off x="1749704" y="2111363"/>
          <a:ext cx="7985140" cy="435133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733844">
                  <a:extLst>
                    <a:ext uri="{9D8B030D-6E8A-4147-A177-3AD203B41FA5}">
                      <a16:colId xmlns:a16="http://schemas.microsoft.com/office/drawing/2014/main" val="161713932"/>
                    </a:ext>
                  </a:extLst>
                </a:gridCol>
                <a:gridCol w="2625648">
                  <a:extLst>
                    <a:ext uri="{9D8B030D-6E8A-4147-A177-3AD203B41FA5}">
                      <a16:colId xmlns:a16="http://schemas.microsoft.com/office/drawing/2014/main" val="671411118"/>
                    </a:ext>
                  </a:extLst>
                </a:gridCol>
                <a:gridCol w="2625648">
                  <a:extLst>
                    <a:ext uri="{9D8B030D-6E8A-4147-A177-3AD203B41FA5}">
                      <a16:colId xmlns:a16="http://schemas.microsoft.com/office/drawing/2014/main" val="2987317168"/>
                    </a:ext>
                  </a:extLst>
                </a:gridCol>
              </a:tblGrid>
              <a:tr h="47077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ed critical residues of IL-17AF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ed critical residues of IL-17RA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3841340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yptanthr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n120, Thr121, Cys290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2873206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inopter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137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n67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4259001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lsidomine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r93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77, Cys126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2364388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cet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g72, Asn73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185, Cys196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6797336"/>
                  </a:ext>
                </a:extLst>
              </a:tr>
              <a:tr h="25132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cetin 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185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0468720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isqualic 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90,Tyr93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62, CyS77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7710365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igen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31428168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ionine sulfoximine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72561309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ygdal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90, Arg131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3931693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marin 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7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90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62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7439535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irub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5028108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quinolone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15504772"/>
                  </a:ext>
                </a:extLst>
              </a:tr>
              <a:tr h="22569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aempferol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37572262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citriol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634517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rulic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8443529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alapril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9019894"/>
                  </a:ext>
                </a:extLst>
              </a:tr>
              <a:tr h="2061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emisin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g67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3073960"/>
                  </a:ext>
                </a:extLst>
              </a:tr>
              <a:tr h="3107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ytic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521" marR="67521" marT="9378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28578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589531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</p:bld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C668352A-4068-29F6-E326-873E9632F24A}"/>
              </a:ext>
            </a:extLst>
          </p:cNvPr>
          <p:cNvSpPr/>
          <p:nvPr/>
        </p:nvSpPr>
        <p:spPr>
          <a:xfrm>
            <a:off x="334477" y="5856916"/>
            <a:ext cx="10443886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i: Dexamethasone docking IL-17/IL-17R (5nan)</a:t>
            </a:r>
          </a:p>
        </p:txBody>
      </p:sp>
      <p:pic>
        <p:nvPicPr>
          <p:cNvPr id="5" name="Picture 4" descr="A close-up of a structure&#10;&#10;AI-generated content may be incorrect.">
            <a:extLst>
              <a:ext uri="{FF2B5EF4-FFF2-40B4-BE49-F238E27FC236}">
                <a16:creationId xmlns:a16="http://schemas.microsoft.com/office/drawing/2014/main" id="{CBC80FD3-9486-FDD2-1FC9-BEBCA8FC62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4" t="2052" r="653" b="672"/>
          <a:stretch>
            <a:fillRect/>
          </a:stretch>
        </p:blipFill>
        <p:spPr>
          <a:xfrm>
            <a:off x="449705" y="464695"/>
            <a:ext cx="10747947" cy="52165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911949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FABAEA50-9156-744C-3AB9-B2352515A1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9716" y="765038"/>
            <a:ext cx="10052567" cy="5327924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CA018DA2-F17D-F0CC-E015-412FFEECEACD}"/>
              </a:ext>
            </a:extLst>
          </p:cNvPr>
          <p:cNvSpPr/>
          <p:nvPr/>
        </p:nvSpPr>
        <p:spPr>
          <a:xfrm>
            <a:off x="1035687" y="6145589"/>
            <a:ext cx="9520556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j: Enalapril docking IL-17F/IL-17R (5nan)</a:t>
            </a:r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0047D54B-7942-4634-383C-58ADE6AD2700}"/>
              </a:ext>
            </a:extLst>
          </p:cNvPr>
          <p:cNvSpPr/>
          <p:nvPr/>
        </p:nvSpPr>
        <p:spPr>
          <a:xfrm rot="14323150">
            <a:off x="9458692" y="4457263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3402126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5A6DC89D-3385-1542-C977-C15456EF5B06}"/>
              </a:ext>
            </a:extLst>
          </p:cNvPr>
          <p:cNvSpPr/>
          <p:nvPr/>
        </p:nvSpPr>
        <p:spPr>
          <a:xfrm>
            <a:off x="1228046" y="6145589"/>
            <a:ext cx="9135835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k: Ferulic docking IL-17F/IL-17R (5nan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B11224F-75B5-CFFD-397C-2D64A12B91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8376" y="500630"/>
            <a:ext cx="10555173" cy="5287113"/>
          </a:xfrm>
          <a:prstGeom prst="rect">
            <a:avLst/>
          </a:prstGeom>
        </p:spPr>
      </p:pic>
      <p:sp>
        <p:nvSpPr>
          <p:cNvPr id="8" name="Arrow: Right 7">
            <a:extLst>
              <a:ext uri="{FF2B5EF4-FFF2-40B4-BE49-F238E27FC236}">
                <a16:creationId xmlns:a16="http://schemas.microsoft.com/office/drawing/2014/main" id="{D1EBD00E-2455-C8AC-BCA2-20461DCAE750}"/>
              </a:ext>
            </a:extLst>
          </p:cNvPr>
          <p:cNvSpPr/>
          <p:nvPr/>
        </p:nvSpPr>
        <p:spPr>
          <a:xfrm rot="15795605">
            <a:off x="8730783" y="4018434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01962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1FB81436-52EA-5B04-9F51-2344E698B6B4}"/>
              </a:ext>
            </a:extLst>
          </p:cNvPr>
          <p:cNvSpPr/>
          <p:nvPr/>
        </p:nvSpPr>
        <p:spPr>
          <a:xfrm>
            <a:off x="1223408" y="5930644"/>
            <a:ext cx="9546204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l: Indirubin docking IL-17F/IL-17R (5nan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134A88C-CEF0-9165-9C94-12536B6FEF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5634" y="511737"/>
            <a:ext cx="10221751" cy="5325218"/>
          </a:xfrm>
          <a:prstGeom prst="rect">
            <a:avLst/>
          </a:prstGeom>
        </p:spPr>
      </p:pic>
      <p:sp>
        <p:nvSpPr>
          <p:cNvPr id="8" name="Arrow: Right 7">
            <a:extLst>
              <a:ext uri="{FF2B5EF4-FFF2-40B4-BE49-F238E27FC236}">
                <a16:creationId xmlns:a16="http://schemas.microsoft.com/office/drawing/2014/main" id="{BBE76742-F5B1-C723-F3F6-4311FC7780D5}"/>
              </a:ext>
            </a:extLst>
          </p:cNvPr>
          <p:cNvSpPr/>
          <p:nvPr/>
        </p:nvSpPr>
        <p:spPr>
          <a:xfrm rot="5400000">
            <a:off x="10686606" y="3099790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1C96F2BA-A1D5-F561-31C2-D7B48EEB2CCE}"/>
              </a:ext>
            </a:extLst>
          </p:cNvPr>
          <p:cNvSpPr/>
          <p:nvPr/>
        </p:nvSpPr>
        <p:spPr>
          <a:xfrm rot="13678054">
            <a:off x="8760260" y="4075450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14387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220B07F7-9B19-391A-EAE4-15A73CF1FAD4}"/>
              </a:ext>
            </a:extLst>
          </p:cNvPr>
          <p:cNvSpPr/>
          <p:nvPr/>
        </p:nvSpPr>
        <p:spPr>
          <a:xfrm>
            <a:off x="784466" y="6071884"/>
            <a:ext cx="10366942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m: </a:t>
            </a:r>
            <a:r>
              <a:rPr lang="en-US" sz="36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Isoquinolone</a:t>
            </a:r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docking IL-17F/IL-17R (5nan)</a:t>
            </a: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1F3F8697-2E7F-F916-133F-66979AC7DD48}"/>
              </a:ext>
            </a:extLst>
          </p:cNvPr>
          <p:cNvSpPr/>
          <p:nvPr/>
        </p:nvSpPr>
        <p:spPr>
          <a:xfrm rot="15807345">
            <a:off x="9671110" y="3436089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7021450-42F6-F713-A7D6-B052548422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8887" y="569123"/>
            <a:ext cx="10574226" cy="5334744"/>
          </a:xfrm>
          <a:prstGeom prst="rect">
            <a:avLst/>
          </a:prstGeom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9A894106-D03B-9C0E-7CE8-0A6FA0C11DF6}"/>
              </a:ext>
            </a:extLst>
          </p:cNvPr>
          <p:cNvSpPr/>
          <p:nvPr/>
        </p:nvSpPr>
        <p:spPr>
          <a:xfrm rot="5400000">
            <a:off x="7874967" y="1420068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AB9EF4B9-0CE6-E2A8-9CF5-FBFF16756739}"/>
              </a:ext>
            </a:extLst>
          </p:cNvPr>
          <p:cNvSpPr/>
          <p:nvPr/>
        </p:nvSpPr>
        <p:spPr>
          <a:xfrm rot="5400000">
            <a:off x="8883960" y="1254057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B9CC98B0-1355-9673-0631-453BB80393CD}"/>
              </a:ext>
            </a:extLst>
          </p:cNvPr>
          <p:cNvSpPr/>
          <p:nvPr/>
        </p:nvSpPr>
        <p:spPr>
          <a:xfrm rot="13678054">
            <a:off x="10731565" y="3992324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44329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9C9D159A-33BA-65A4-81EE-891DF4BA6045}"/>
              </a:ext>
            </a:extLst>
          </p:cNvPr>
          <p:cNvSpPr/>
          <p:nvPr/>
        </p:nvSpPr>
        <p:spPr>
          <a:xfrm>
            <a:off x="1143189" y="5777957"/>
            <a:ext cx="10161757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n: Kaempferol docking IL-17F/IL-17R (5nan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E14ECEA-A914-E582-57F4-0EFED97545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6376" y="433712"/>
            <a:ext cx="10850489" cy="5344271"/>
          </a:xfrm>
          <a:prstGeom prst="rect">
            <a:avLst/>
          </a:prstGeom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515E3C8C-9D46-E9D0-6A93-B92313F55ABE}"/>
              </a:ext>
            </a:extLst>
          </p:cNvPr>
          <p:cNvSpPr/>
          <p:nvPr/>
        </p:nvSpPr>
        <p:spPr>
          <a:xfrm rot="5400000">
            <a:off x="6823933" y="2937771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F5DF4491-FDA1-6E21-7EA6-DF753E24B716}"/>
              </a:ext>
            </a:extLst>
          </p:cNvPr>
          <p:cNvSpPr/>
          <p:nvPr/>
        </p:nvSpPr>
        <p:spPr>
          <a:xfrm rot="13678054">
            <a:off x="9698411" y="4119607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A9AF6542-6CCF-A25D-26F3-62F8B80475C1}"/>
              </a:ext>
            </a:extLst>
          </p:cNvPr>
          <p:cNvSpPr/>
          <p:nvPr/>
        </p:nvSpPr>
        <p:spPr>
          <a:xfrm rot="5400000">
            <a:off x="7420800" y="2354435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83054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55FBEF6-906B-6952-07DA-08FCA289DB7D}"/>
              </a:ext>
            </a:extLst>
          </p:cNvPr>
          <p:cNvSpPr/>
          <p:nvPr/>
        </p:nvSpPr>
        <p:spPr>
          <a:xfrm>
            <a:off x="951002" y="5802265"/>
            <a:ext cx="10289997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o: </a:t>
            </a:r>
            <a:r>
              <a:rPr lang="en-US" sz="36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Molsidomine</a:t>
            </a:r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docking IL-17F/IL-17R (5nan)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ECCC60C-1CCA-0BC1-BBBB-C17829F0F8FA}"/>
              </a:ext>
            </a:extLst>
          </p:cNvPr>
          <p:cNvGrpSpPr/>
          <p:nvPr/>
        </p:nvGrpSpPr>
        <p:grpSpPr>
          <a:xfrm>
            <a:off x="454430" y="581215"/>
            <a:ext cx="11283140" cy="4891207"/>
            <a:chOff x="742807" y="670579"/>
            <a:chExt cx="11283140" cy="4891207"/>
          </a:xfrm>
        </p:grpSpPr>
        <p:pic>
          <p:nvPicPr>
            <p:cNvPr id="3" name="Picture 2" descr="A close-up of a dna model&#10;&#10;Description automatically generated">
              <a:extLst>
                <a:ext uri="{FF2B5EF4-FFF2-40B4-BE49-F238E27FC236}">
                  <a16:creationId xmlns:a16="http://schemas.microsoft.com/office/drawing/2014/main" id="{C34E7DCF-5B62-FFE7-5B16-35A4719A5A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2807" y="670580"/>
              <a:ext cx="5733333" cy="4891206"/>
            </a:xfrm>
            <a:prstGeom prst="rect">
              <a:avLst/>
            </a:prstGeom>
          </p:spPr>
        </p:pic>
        <p:pic>
          <p:nvPicPr>
            <p:cNvPr id="8" name="Picture 7" descr="A diagram of a molecule&#10;&#10;Description automatically generated">
              <a:extLst>
                <a:ext uri="{FF2B5EF4-FFF2-40B4-BE49-F238E27FC236}">
                  <a16:creationId xmlns:a16="http://schemas.microsoft.com/office/drawing/2014/main" id="{67B2FD0A-EB6C-4389-F92A-7A9849B8C43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76140" y="670579"/>
              <a:ext cx="5549807" cy="4891206"/>
            </a:xfrm>
            <a:prstGeom prst="rect">
              <a:avLst/>
            </a:prstGeom>
          </p:spPr>
        </p:pic>
      </p:grpSp>
      <p:sp>
        <p:nvSpPr>
          <p:cNvPr id="9" name="Arrow: Right 8">
            <a:extLst>
              <a:ext uri="{FF2B5EF4-FFF2-40B4-BE49-F238E27FC236}">
                <a16:creationId xmlns:a16="http://schemas.microsoft.com/office/drawing/2014/main" id="{6BC43717-E987-E4F3-3DD8-3EA5602A8D88}"/>
              </a:ext>
            </a:extLst>
          </p:cNvPr>
          <p:cNvSpPr/>
          <p:nvPr/>
        </p:nvSpPr>
        <p:spPr>
          <a:xfrm rot="16028427">
            <a:off x="8226770" y="3714929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1DFFFB27-AE16-8BB7-9C66-79472EC51D13}"/>
              </a:ext>
            </a:extLst>
          </p:cNvPr>
          <p:cNvSpPr/>
          <p:nvPr/>
        </p:nvSpPr>
        <p:spPr>
          <a:xfrm rot="16200000">
            <a:off x="8851085" y="3813168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6CCD41CF-D202-9477-078C-AFCDC0D38947}"/>
              </a:ext>
            </a:extLst>
          </p:cNvPr>
          <p:cNvSpPr/>
          <p:nvPr/>
        </p:nvSpPr>
        <p:spPr>
          <a:xfrm rot="6587557">
            <a:off x="8315877" y="1522254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31162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2A77198-D02E-67F4-DAD2-F631BB2B89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0266" y="364437"/>
            <a:ext cx="10517068" cy="530616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4E53B13-24D6-A6B8-3DF1-4AFD889366B2}"/>
              </a:ext>
            </a:extLst>
          </p:cNvPr>
          <p:cNvSpPr/>
          <p:nvPr/>
        </p:nvSpPr>
        <p:spPr>
          <a:xfrm>
            <a:off x="1592205" y="5802265"/>
            <a:ext cx="9007595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p: Phytic docking IL-17F/IL-17R (5nan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89C2AF1F-32DF-2B74-D333-E0471F77FFC6}"/>
              </a:ext>
            </a:extLst>
          </p:cNvPr>
          <p:cNvSpPr/>
          <p:nvPr/>
        </p:nvSpPr>
        <p:spPr>
          <a:xfrm rot="6587557">
            <a:off x="9698908" y="699293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16503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B5DD886-D80D-C542-E55D-8B2D5CDD8B9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59D4763D-70F4-71F6-3575-AAF39AB1BF38}"/>
              </a:ext>
            </a:extLst>
          </p:cNvPr>
          <p:cNvSpPr/>
          <p:nvPr/>
        </p:nvSpPr>
        <p:spPr>
          <a:xfrm>
            <a:off x="1207483" y="5847906"/>
            <a:ext cx="9777036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q: Quercetin docking IL-17F/IL-17R (5nan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5ECE717-2AE8-3D36-7CB1-92A3B06B79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3176" y="541741"/>
            <a:ext cx="10545647" cy="5306165"/>
          </a:xfrm>
          <a:prstGeom prst="rect">
            <a:avLst/>
          </a:prstGeom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6B9591AD-A8C6-013E-2643-E97E6DCB5D75}"/>
              </a:ext>
            </a:extLst>
          </p:cNvPr>
          <p:cNvSpPr/>
          <p:nvPr/>
        </p:nvSpPr>
        <p:spPr>
          <a:xfrm rot="5400000">
            <a:off x="9568081" y="1154231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26636A8E-BEAA-CE13-B165-759745B2A72E}"/>
              </a:ext>
            </a:extLst>
          </p:cNvPr>
          <p:cNvSpPr/>
          <p:nvPr/>
        </p:nvSpPr>
        <p:spPr>
          <a:xfrm rot="18762206">
            <a:off x="8173190" y="3556254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E5415139-8B2F-1071-5E77-01B4C386F5DD}"/>
              </a:ext>
            </a:extLst>
          </p:cNvPr>
          <p:cNvSpPr/>
          <p:nvPr/>
        </p:nvSpPr>
        <p:spPr>
          <a:xfrm rot="18376436">
            <a:off x="9220467" y="4330845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73375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F9A21227-2FB4-07C1-F7A1-41B1E629C89E}"/>
              </a:ext>
            </a:extLst>
          </p:cNvPr>
          <p:cNvSpPr/>
          <p:nvPr/>
        </p:nvSpPr>
        <p:spPr>
          <a:xfrm>
            <a:off x="1297251" y="5723691"/>
            <a:ext cx="9597500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r: Quinapril docking IL-17F/IL-17R (5nan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68B95587-E381-CE0F-8500-91AB538AAD55}"/>
              </a:ext>
            </a:extLst>
          </p:cNvPr>
          <p:cNvSpPr/>
          <p:nvPr/>
        </p:nvSpPr>
        <p:spPr>
          <a:xfrm rot="15889974">
            <a:off x="8636384" y="3669699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0836D63C-26D0-9DB5-C3B1-F7AAFDCAC2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676" y="487978"/>
            <a:ext cx="11088647" cy="53442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51828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E16A2BB-B2BE-7E32-73AD-850000D2F540}"/>
              </a:ext>
            </a:extLst>
          </p:cNvPr>
          <p:cNvSpPr/>
          <p:nvPr/>
        </p:nvSpPr>
        <p:spPr>
          <a:xfrm>
            <a:off x="1386922" y="5934670"/>
            <a:ext cx="9418156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a: Acacetin docking IL-17F/IL-17R (5nan)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5871D50-03BC-CFDC-4F2B-DE0079B513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205" y="276999"/>
            <a:ext cx="10402752" cy="5325218"/>
          </a:xfrm>
          <a:prstGeom prst="rect">
            <a:avLst/>
          </a:prstGeom>
        </p:spPr>
      </p:pic>
      <p:sp>
        <p:nvSpPr>
          <p:cNvPr id="11" name="Arrow: Right 10">
            <a:extLst>
              <a:ext uri="{FF2B5EF4-FFF2-40B4-BE49-F238E27FC236}">
                <a16:creationId xmlns:a16="http://schemas.microsoft.com/office/drawing/2014/main" id="{C6960094-348D-E919-9017-C93856828E0A}"/>
              </a:ext>
            </a:extLst>
          </p:cNvPr>
          <p:cNvSpPr/>
          <p:nvPr/>
        </p:nvSpPr>
        <p:spPr>
          <a:xfrm rot="21245077">
            <a:off x="6650785" y="1523298"/>
            <a:ext cx="177754" cy="196835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79BF480B-A4A9-16BB-76A5-104E88924109}"/>
              </a:ext>
            </a:extLst>
          </p:cNvPr>
          <p:cNvSpPr/>
          <p:nvPr/>
        </p:nvSpPr>
        <p:spPr>
          <a:xfrm rot="13632134">
            <a:off x="8883961" y="3091213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Arrow: Right 2">
            <a:extLst>
              <a:ext uri="{FF2B5EF4-FFF2-40B4-BE49-F238E27FC236}">
                <a16:creationId xmlns:a16="http://schemas.microsoft.com/office/drawing/2014/main" id="{372E85AF-72CF-0E8A-D475-ED62C2FAFDDF}"/>
              </a:ext>
            </a:extLst>
          </p:cNvPr>
          <p:cNvSpPr/>
          <p:nvPr/>
        </p:nvSpPr>
        <p:spPr>
          <a:xfrm rot="15392563">
            <a:off x="8293412" y="3448042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3E6CF372-B559-599A-3B26-96F9B2434026}"/>
              </a:ext>
            </a:extLst>
          </p:cNvPr>
          <p:cNvSpPr/>
          <p:nvPr/>
        </p:nvSpPr>
        <p:spPr>
          <a:xfrm rot="15049697">
            <a:off x="7274237" y="4148488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95419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C2011AC8-BF90-F6CB-FF11-8FD5BA8B6F20}"/>
              </a:ext>
            </a:extLst>
          </p:cNvPr>
          <p:cNvSpPr/>
          <p:nvPr/>
        </p:nvSpPr>
        <p:spPr>
          <a:xfrm>
            <a:off x="1181839" y="5760085"/>
            <a:ext cx="9828333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s: </a:t>
            </a:r>
            <a:r>
              <a:rPr lang="en-US" sz="36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Quisqualic</a:t>
            </a:r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docking IL-17F/IL-17R (5nan)</a:t>
            </a:r>
          </a:p>
        </p:txBody>
      </p:sp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946A7219-ACFA-32CF-EEB6-2309D399AA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75" t="16650" r="1092" b="10617"/>
          <a:stretch/>
        </p:blipFill>
        <p:spPr>
          <a:xfrm>
            <a:off x="1181839" y="265604"/>
            <a:ext cx="10446706" cy="5213047"/>
          </a:xfrm>
          <a:prstGeom prst="rect">
            <a:avLst/>
          </a:prstGeom>
        </p:spPr>
      </p:pic>
      <p:sp>
        <p:nvSpPr>
          <p:cNvPr id="9" name="Arrow: Right 8">
            <a:extLst>
              <a:ext uri="{FF2B5EF4-FFF2-40B4-BE49-F238E27FC236}">
                <a16:creationId xmlns:a16="http://schemas.microsoft.com/office/drawing/2014/main" id="{0CE052AD-C4EB-7080-B9F1-523A7C3EAFD6}"/>
              </a:ext>
            </a:extLst>
          </p:cNvPr>
          <p:cNvSpPr/>
          <p:nvPr/>
        </p:nvSpPr>
        <p:spPr>
          <a:xfrm rot="15490567">
            <a:off x="9524598" y="3786841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C2CBB7FA-D393-CB18-8B0F-3EAB4F48DFBA}"/>
              </a:ext>
            </a:extLst>
          </p:cNvPr>
          <p:cNvSpPr/>
          <p:nvPr/>
        </p:nvSpPr>
        <p:spPr>
          <a:xfrm rot="5400000">
            <a:off x="7188866" y="2185442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43062B6C-1DB9-F9AF-B7D2-1B6D628776AE}"/>
              </a:ext>
            </a:extLst>
          </p:cNvPr>
          <p:cNvSpPr/>
          <p:nvPr/>
        </p:nvSpPr>
        <p:spPr>
          <a:xfrm rot="15761495">
            <a:off x="8050184" y="4115272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Arrow: Right 12">
            <a:extLst>
              <a:ext uri="{FF2B5EF4-FFF2-40B4-BE49-F238E27FC236}">
                <a16:creationId xmlns:a16="http://schemas.microsoft.com/office/drawing/2014/main" id="{C5572C96-B357-CBF2-74DB-4F9B25DF098A}"/>
              </a:ext>
            </a:extLst>
          </p:cNvPr>
          <p:cNvSpPr/>
          <p:nvPr/>
        </p:nvSpPr>
        <p:spPr>
          <a:xfrm rot="13678054">
            <a:off x="10672188" y="2591034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67561C55-386B-D6E5-A8A8-46F303DB8055}"/>
              </a:ext>
            </a:extLst>
          </p:cNvPr>
          <p:cNvSpPr/>
          <p:nvPr/>
        </p:nvSpPr>
        <p:spPr>
          <a:xfrm rot="16024586">
            <a:off x="7363132" y="3700373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21823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B949429-F05D-A42F-2CB8-E230E5029B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5063" y="425341"/>
            <a:ext cx="10821910" cy="533474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294E3EB-8306-789A-A485-8186957064FB}"/>
              </a:ext>
            </a:extLst>
          </p:cNvPr>
          <p:cNvSpPr/>
          <p:nvPr/>
        </p:nvSpPr>
        <p:spPr>
          <a:xfrm>
            <a:off x="-42850" y="5760085"/>
            <a:ext cx="12277721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t: Methionine </a:t>
            </a:r>
            <a:r>
              <a:rPr lang="en-US" sz="36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sulfoximine</a:t>
            </a:r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docking IL-17F/IL-17R (5nan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98A4A901-1B27-D084-DA2C-F59B65E00E2B}"/>
              </a:ext>
            </a:extLst>
          </p:cNvPr>
          <p:cNvSpPr/>
          <p:nvPr/>
        </p:nvSpPr>
        <p:spPr>
          <a:xfrm rot="5400000">
            <a:off x="7369303" y="3343929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0C39911C-64DF-35B0-9ABD-F615D5A64CD1}"/>
              </a:ext>
            </a:extLst>
          </p:cNvPr>
          <p:cNvSpPr/>
          <p:nvPr/>
        </p:nvSpPr>
        <p:spPr>
          <a:xfrm rot="5400000">
            <a:off x="7775702" y="497567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2AB722B2-4CC5-A092-EC54-4AE23C2437B2}"/>
              </a:ext>
            </a:extLst>
          </p:cNvPr>
          <p:cNvSpPr/>
          <p:nvPr/>
        </p:nvSpPr>
        <p:spPr>
          <a:xfrm rot="13678054">
            <a:off x="9336549" y="4748607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4F3B663F-0076-9AE5-77C9-2820F6D76841}"/>
              </a:ext>
            </a:extLst>
          </p:cNvPr>
          <p:cNvSpPr/>
          <p:nvPr/>
        </p:nvSpPr>
        <p:spPr>
          <a:xfrm rot="5959211">
            <a:off x="8436077" y="676261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83397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577402B5-0793-ABDF-693D-A3686E5AA0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597" y="790206"/>
            <a:ext cx="11326806" cy="5277587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D89275D-0431-2EAE-3CA1-0F7B90ED8D44}"/>
              </a:ext>
            </a:extLst>
          </p:cNvPr>
          <p:cNvSpPr/>
          <p:nvPr/>
        </p:nvSpPr>
        <p:spPr>
          <a:xfrm>
            <a:off x="976651" y="6067793"/>
            <a:ext cx="10238701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u: Nitazoxanide docking IL-17F/IL-17R (5nan)</a:t>
            </a:r>
          </a:p>
        </p:txBody>
      </p:sp>
    </p:spTree>
    <p:extLst>
      <p:ext uri="{BB962C8B-B14F-4D97-AF65-F5344CB8AC3E}">
        <p14:creationId xmlns:p14="http://schemas.microsoft.com/office/powerpoint/2010/main" val="138679313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C3676ED5-26DF-63CC-B7C9-6D0B933EDD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281" y="785443"/>
            <a:ext cx="10831437" cy="5287113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39328D2-9A07-BB40-6D3C-C6269442A88E}"/>
              </a:ext>
            </a:extLst>
          </p:cNvPr>
          <p:cNvSpPr/>
          <p:nvPr/>
        </p:nvSpPr>
        <p:spPr>
          <a:xfrm>
            <a:off x="1117713" y="6072556"/>
            <a:ext cx="9956572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v: Remdesivir docking IL-17F/IL-17R (5nan)</a:t>
            </a:r>
          </a:p>
        </p:txBody>
      </p:sp>
    </p:spTree>
    <p:extLst>
      <p:ext uri="{BB962C8B-B14F-4D97-AF65-F5344CB8AC3E}">
        <p14:creationId xmlns:p14="http://schemas.microsoft.com/office/powerpoint/2010/main" val="325222809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DCF9497-CCD7-AD78-8A71-DFD27A8D97DB}"/>
              </a:ext>
            </a:extLst>
          </p:cNvPr>
          <p:cNvSpPr/>
          <p:nvPr/>
        </p:nvSpPr>
        <p:spPr>
          <a:xfrm>
            <a:off x="775638" y="5760085"/>
            <a:ext cx="10640733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w: Thymoquinone docking IL-17F/IL-17R (5nan)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9D3F35A9-5B13-F8F2-7D8E-7C39C5452827}"/>
              </a:ext>
            </a:extLst>
          </p:cNvPr>
          <p:cNvGrpSpPr/>
          <p:nvPr/>
        </p:nvGrpSpPr>
        <p:grpSpPr>
          <a:xfrm>
            <a:off x="255858" y="314586"/>
            <a:ext cx="11564594" cy="5390476"/>
            <a:chOff x="255858" y="314586"/>
            <a:chExt cx="11564594" cy="5390476"/>
          </a:xfrm>
        </p:grpSpPr>
        <p:pic>
          <p:nvPicPr>
            <p:cNvPr id="4" name="Picture 3" descr="A close-up of a structure&#10;&#10;Description automatically generated">
              <a:extLst>
                <a:ext uri="{FF2B5EF4-FFF2-40B4-BE49-F238E27FC236}">
                  <a16:creationId xmlns:a16="http://schemas.microsoft.com/office/drawing/2014/main" id="{BD64B2C1-8B9B-7B64-0D23-9B78D418127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4433"/>
            <a:stretch/>
          </p:blipFill>
          <p:spPr>
            <a:xfrm>
              <a:off x="255858" y="314586"/>
              <a:ext cx="6103780" cy="5390476"/>
            </a:xfrm>
            <a:prstGeom prst="rect">
              <a:avLst/>
            </a:prstGeom>
          </p:spPr>
        </p:pic>
        <p:pic>
          <p:nvPicPr>
            <p:cNvPr id="9" name="Picture 8" descr="A diagram of a molecule&#10;&#10;Description automatically generated">
              <a:extLst>
                <a:ext uri="{FF2B5EF4-FFF2-40B4-BE49-F238E27FC236}">
                  <a16:creationId xmlns:a16="http://schemas.microsoft.com/office/drawing/2014/main" id="{0F2E53E4-1369-DB32-BE2C-E0B5321EE6C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29976" y="314586"/>
              <a:ext cx="5390476" cy="539047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32931495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9DC77A5-9C17-DA33-C17C-EAF8A43E8744}"/>
              </a:ext>
            </a:extLst>
          </p:cNvPr>
          <p:cNvSpPr/>
          <p:nvPr/>
        </p:nvSpPr>
        <p:spPr>
          <a:xfrm>
            <a:off x="1168465" y="5887813"/>
            <a:ext cx="9855070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x: </a:t>
            </a:r>
            <a:r>
              <a:rPr lang="en-US" sz="36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Tryptanthrin</a:t>
            </a:r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docking IL-17/IL-17R (5nan)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AE75D17-36CE-B936-1C74-5A44CE852E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9386" y="572121"/>
            <a:ext cx="10840963" cy="5315692"/>
          </a:xfrm>
          <a:prstGeom prst="rect">
            <a:avLst/>
          </a:prstGeom>
        </p:spPr>
      </p:pic>
      <p:sp>
        <p:nvSpPr>
          <p:cNvPr id="11" name="Arrow: Right 10">
            <a:extLst>
              <a:ext uri="{FF2B5EF4-FFF2-40B4-BE49-F238E27FC236}">
                <a16:creationId xmlns:a16="http://schemas.microsoft.com/office/drawing/2014/main" id="{9525620F-5F17-8A80-26AA-D392420EAEBE}"/>
              </a:ext>
            </a:extLst>
          </p:cNvPr>
          <p:cNvSpPr/>
          <p:nvPr/>
        </p:nvSpPr>
        <p:spPr>
          <a:xfrm rot="5200548">
            <a:off x="6742187" y="1549292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9F99A42F-65D7-AE5E-0F2B-823AD68E36E8}"/>
              </a:ext>
            </a:extLst>
          </p:cNvPr>
          <p:cNvSpPr/>
          <p:nvPr/>
        </p:nvSpPr>
        <p:spPr>
          <a:xfrm rot="5400000">
            <a:off x="10957462" y="1753963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8CA39A2D-8FE3-2CEA-9886-FE1246ABB10F}"/>
              </a:ext>
            </a:extLst>
          </p:cNvPr>
          <p:cNvSpPr/>
          <p:nvPr/>
        </p:nvSpPr>
        <p:spPr>
          <a:xfrm rot="5400000">
            <a:off x="10872390" y="3227902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6845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structure&#10;&#10;AI-generated content may be incorrect.">
            <a:extLst>
              <a:ext uri="{FF2B5EF4-FFF2-40B4-BE49-F238E27FC236}">
                <a16:creationId xmlns:a16="http://schemas.microsoft.com/office/drawing/2014/main" id="{48F8D2C4-3145-8349-A4F2-14B8CA4BE9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986" y="809952"/>
            <a:ext cx="7609668" cy="5238095"/>
          </a:xfrm>
          <a:prstGeom prst="rect">
            <a:avLst/>
          </a:prstGeom>
          <a:ln>
            <a:solidFill>
              <a:schemeClr val="bg2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3E085FB-57E7-078B-9132-C19CD7DED3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5419" y="809952"/>
            <a:ext cx="5353797" cy="5153051"/>
          </a:xfrm>
          <a:prstGeom prst="rect">
            <a:avLst/>
          </a:prstGeom>
          <a:ln>
            <a:solidFill>
              <a:schemeClr val="bg2"/>
            </a:solidFill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E75FF9F4-8612-C6EB-3E61-593D32754351}"/>
              </a:ext>
            </a:extLst>
          </p:cNvPr>
          <p:cNvSpPr/>
          <p:nvPr/>
        </p:nvSpPr>
        <p:spPr>
          <a:xfrm>
            <a:off x="1015026" y="5934670"/>
            <a:ext cx="10161949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b: Aminopterin docking IL-17F/IL-17R (5nan)</a:t>
            </a:r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4F72F528-6166-B7B7-4F90-51415179FBC1}"/>
              </a:ext>
            </a:extLst>
          </p:cNvPr>
          <p:cNvSpPr/>
          <p:nvPr/>
        </p:nvSpPr>
        <p:spPr>
          <a:xfrm rot="16200000">
            <a:off x="9031858" y="3244582"/>
            <a:ext cx="177754" cy="196835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C1F6BE2F-A206-0F51-2606-18D0FFA661C0}"/>
              </a:ext>
            </a:extLst>
          </p:cNvPr>
          <p:cNvSpPr/>
          <p:nvPr/>
        </p:nvSpPr>
        <p:spPr>
          <a:xfrm rot="15049697">
            <a:off x="10248791" y="2716295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4530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0083FFA-7633-2FBF-F9AC-829E3198EC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2650" y="323480"/>
            <a:ext cx="10926700" cy="5296639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786C126-7D66-DAEE-01BE-3D812F7561B4}"/>
              </a:ext>
            </a:extLst>
          </p:cNvPr>
          <p:cNvSpPr/>
          <p:nvPr/>
        </p:nvSpPr>
        <p:spPr>
          <a:xfrm>
            <a:off x="1168916" y="6020239"/>
            <a:ext cx="9854172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c: Amygdalin docking IL-17F/IL-17R (5nan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70788950-477E-8F87-6D45-2064B9F71620}"/>
              </a:ext>
            </a:extLst>
          </p:cNvPr>
          <p:cNvSpPr/>
          <p:nvPr/>
        </p:nvSpPr>
        <p:spPr>
          <a:xfrm rot="19415158">
            <a:off x="8778154" y="3343929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D1BBDCB6-B2AE-004B-5EFD-568B9696A610}"/>
              </a:ext>
            </a:extLst>
          </p:cNvPr>
          <p:cNvSpPr/>
          <p:nvPr/>
        </p:nvSpPr>
        <p:spPr>
          <a:xfrm rot="19415158">
            <a:off x="6448610" y="4645861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4383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600C0AF9-7CC5-88B5-544A-8854046E333D}"/>
              </a:ext>
            </a:extLst>
          </p:cNvPr>
          <p:cNvSpPr/>
          <p:nvPr/>
        </p:nvSpPr>
        <p:spPr>
          <a:xfrm>
            <a:off x="1348450" y="6082082"/>
            <a:ext cx="9495100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d: Apigenin docking IL-17F/IL-17R (5nan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3D85654-BE67-773D-061F-C32EDC8AD3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6537" y="509217"/>
            <a:ext cx="10574226" cy="5306165"/>
          </a:xfrm>
          <a:prstGeom prst="rect">
            <a:avLst/>
          </a:prstGeom>
        </p:spPr>
      </p:pic>
      <p:sp>
        <p:nvSpPr>
          <p:cNvPr id="9" name="Arrow: Right 8">
            <a:extLst>
              <a:ext uri="{FF2B5EF4-FFF2-40B4-BE49-F238E27FC236}">
                <a16:creationId xmlns:a16="http://schemas.microsoft.com/office/drawing/2014/main" id="{3364F959-9575-06CA-8755-7746BAB3254E}"/>
              </a:ext>
            </a:extLst>
          </p:cNvPr>
          <p:cNvSpPr/>
          <p:nvPr/>
        </p:nvSpPr>
        <p:spPr>
          <a:xfrm rot="15624853">
            <a:off x="10116378" y="3926094"/>
            <a:ext cx="176755" cy="166763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779865FC-022B-EF9E-D49E-6C27620336F5}"/>
              </a:ext>
            </a:extLst>
          </p:cNvPr>
          <p:cNvSpPr/>
          <p:nvPr/>
        </p:nvSpPr>
        <p:spPr>
          <a:xfrm rot="20419409">
            <a:off x="7188354" y="2457218"/>
            <a:ext cx="176755" cy="166763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08F5E36C-C21F-4792-3308-96E3640AD72A}"/>
              </a:ext>
            </a:extLst>
          </p:cNvPr>
          <p:cNvSpPr/>
          <p:nvPr/>
        </p:nvSpPr>
        <p:spPr>
          <a:xfrm rot="15624853">
            <a:off x="9354378" y="4017448"/>
            <a:ext cx="176755" cy="166763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5381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C336D08-D8A2-2AE6-4198-80DDBC7C2A2C}"/>
              </a:ext>
            </a:extLst>
          </p:cNvPr>
          <p:cNvSpPr/>
          <p:nvPr/>
        </p:nvSpPr>
        <p:spPr>
          <a:xfrm>
            <a:off x="1302759" y="5969773"/>
            <a:ext cx="10008061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e: Artemisinin docking IL-17F/IL-17R (5nan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C393673-8FC9-C5D3-2B4C-31AF026579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3176" y="287119"/>
            <a:ext cx="10545647" cy="5353797"/>
          </a:xfrm>
          <a:prstGeom prst="rect">
            <a:avLst/>
          </a:prstGeom>
        </p:spPr>
      </p:pic>
      <p:sp>
        <p:nvSpPr>
          <p:cNvPr id="10" name="Arrow: Right 9">
            <a:extLst>
              <a:ext uri="{FF2B5EF4-FFF2-40B4-BE49-F238E27FC236}">
                <a16:creationId xmlns:a16="http://schemas.microsoft.com/office/drawing/2014/main" id="{F524E89C-AB0D-D1F1-23B7-8E06A4F53977}"/>
              </a:ext>
            </a:extLst>
          </p:cNvPr>
          <p:cNvSpPr/>
          <p:nvPr/>
        </p:nvSpPr>
        <p:spPr>
          <a:xfrm rot="3149657">
            <a:off x="10848437" y="1675691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1139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1A603E43-F210-3FA2-E731-D40B377E1E62}"/>
              </a:ext>
            </a:extLst>
          </p:cNvPr>
          <p:cNvSpPr/>
          <p:nvPr/>
        </p:nvSpPr>
        <p:spPr>
          <a:xfrm>
            <a:off x="988031" y="6096372"/>
            <a:ext cx="9546204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f: Calcitriol docking IL-17F/IL-17R (5nan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6124F78-0B2A-CBBA-4A54-59BF1D4EA7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1255" y="771154"/>
            <a:ext cx="10669489" cy="5315692"/>
          </a:xfrm>
          <a:prstGeom prst="rect">
            <a:avLst/>
          </a:prstGeom>
        </p:spPr>
      </p:pic>
      <p:sp>
        <p:nvSpPr>
          <p:cNvPr id="9" name="Arrow: Right 8">
            <a:extLst>
              <a:ext uri="{FF2B5EF4-FFF2-40B4-BE49-F238E27FC236}">
                <a16:creationId xmlns:a16="http://schemas.microsoft.com/office/drawing/2014/main" id="{83485B75-D93A-8BCE-7666-8AAF21B5CC6B}"/>
              </a:ext>
            </a:extLst>
          </p:cNvPr>
          <p:cNvSpPr/>
          <p:nvPr/>
        </p:nvSpPr>
        <p:spPr>
          <a:xfrm rot="15634350">
            <a:off x="10217815" y="4471443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5665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B2EFCEB-E9C2-DAED-74D5-49B04CFF15CC}"/>
              </a:ext>
            </a:extLst>
          </p:cNvPr>
          <p:cNvSpPr/>
          <p:nvPr/>
        </p:nvSpPr>
        <p:spPr>
          <a:xfrm>
            <a:off x="1058903" y="6110661"/>
            <a:ext cx="9341019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g: Coumarin docking IL-17/IL-17R (5nan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B2D570E-CE16-8F62-3960-9FAEEE4947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7892" y="590180"/>
            <a:ext cx="10679015" cy="5296639"/>
          </a:xfrm>
          <a:prstGeom prst="rect">
            <a:avLst/>
          </a:prstGeom>
        </p:spPr>
      </p:pic>
      <p:sp>
        <p:nvSpPr>
          <p:cNvPr id="10" name="Arrow: Right 9">
            <a:extLst>
              <a:ext uri="{FF2B5EF4-FFF2-40B4-BE49-F238E27FC236}">
                <a16:creationId xmlns:a16="http://schemas.microsoft.com/office/drawing/2014/main" id="{B7DFC5E9-635B-B053-1576-5ED20399A475}"/>
              </a:ext>
            </a:extLst>
          </p:cNvPr>
          <p:cNvSpPr/>
          <p:nvPr/>
        </p:nvSpPr>
        <p:spPr>
          <a:xfrm rot="15634350">
            <a:off x="10806395" y="3903884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7F166E74-7992-D8F2-97C5-C9FF7C195855}"/>
              </a:ext>
            </a:extLst>
          </p:cNvPr>
          <p:cNvSpPr/>
          <p:nvPr/>
        </p:nvSpPr>
        <p:spPr>
          <a:xfrm rot="5400000">
            <a:off x="8053642" y="3986890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" name="Arrow: Right 2">
            <a:extLst>
              <a:ext uri="{FF2B5EF4-FFF2-40B4-BE49-F238E27FC236}">
                <a16:creationId xmlns:a16="http://schemas.microsoft.com/office/drawing/2014/main" id="{23A29470-132D-562F-D3B9-D563712F2A60}"/>
              </a:ext>
            </a:extLst>
          </p:cNvPr>
          <p:cNvSpPr/>
          <p:nvPr/>
        </p:nvSpPr>
        <p:spPr>
          <a:xfrm rot="4881361">
            <a:off x="7596478" y="1617257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7601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structure&#10;&#10;AI-generated content may be incorrect.">
            <a:extLst>
              <a:ext uri="{FF2B5EF4-FFF2-40B4-BE49-F238E27FC236}">
                <a16:creationId xmlns:a16="http://schemas.microsoft.com/office/drawing/2014/main" id="{82FC0DA7-BCD5-779B-4AE1-C09BA6EC3A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6395" y="799965"/>
            <a:ext cx="9919210" cy="525807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8E01CDF-A869-1CD2-45E9-0EFEAB7E5DE7}"/>
              </a:ext>
            </a:extLst>
          </p:cNvPr>
          <p:cNvSpPr/>
          <p:nvPr/>
        </p:nvSpPr>
        <p:spPr>
          <a:xfrm>
            <a:off x="697887" y="6211669"/>
            <a:ext cx="9777036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4h: Candesartan docking IL-17/IL-17R (5nan)</a:t>
            </a:r>
          </a:p>
        </p:txBody>
      </p:sp>
    </p:spTree>
    <p:extLst>
      <p:ext uri="{BB962C8B-B14F-4D97-AF65-F5344CB8AC3E}">
        <p14:creationId xmlns:p14="http://schemas.microsoft.com/office/powerpoint/2010/main" val="2214169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97</TotalTime>
  <Words>400</Words>
  <Application>Microsoft Office PowerPoint</Application>
  <PresentationFormat>Widescreen</PresentationFormat>
  <Paragraphs>77</Paragraphs>
  <Slides>2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30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deer mohamed adel mahmoud elesseily</dc:creator>
  <cp:lastModifiedBy>Hadeer mohamed adel mahmoud elesseily</cp:lastModifiedBy>
  <cp:revision>78</cp:revision>
  <dcterms:created xsi:type="dcterms:W3CDTF">2024-12-08T16:42:27Z</dcterms:created>
  <dcterms:modified xsi:type="dcterms:W3CDTF">2025-09-17T20:46:02Z</dcterms:modified>
</cp:coreProperties>
</file>